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1" r:id="rId3"/>
    <p:sldId id="260" r:id="rId4"/>
    <p:sldId id="262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1" d="100"/>
          <a:sy n="111" d="100"/>
        </p:scale>
        <p:origin x="120" y="4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076772-0AD1-438B-8116-345630161B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8BE33DA-1AF6-4592-9BEC-B97F2C83C4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24639AA-BFB3-40EF-BBCA-50EE8E511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F6B4E6-2D25-44A9-A3A4-51F8E3885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E9FEC0A-8BC8-4AF6-B055-6DAC7D91A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058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ADC05D-F395-4736-8701-7D2540855C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B225638-5C17-4873-A43E-8D53A09E17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A380614-414D-4E9E-A942-1BFDDCF2C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48CBD2B-79F1-4C86-8143-889990A8C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8C36B6D-C333-4961-9897-3C03FEAD34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4540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D477B5B-D3E6-4A87-B737-D083E36833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FC8E321-8C60-4F43-B392-EEA0B16069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381DA4E-4AD7-46D6-A3D8-07B8C71B4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4EA5B27-3DB8-4E47-BAAE-70C64DC51A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F5357F3-4994-4887-B244-916523AE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3390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96CAFB7-3ADE-4A64-B005-B0805181F6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B16DFC3-97EB-4822-8E18-3078DF008C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F213D95-EE6F-40DC-9BC6-579086EA9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A81675-C357-4ACB-89E4-0AE9D4AC5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94AA805-581C-4BDF-9AC5-AA9B909CE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356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D20EAA-C4E6-4568-8268-DF91E68F18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74F9075-4E17-4C4E-8EDD-2C92FBC51E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2FC72FC-7737-42AB-B42F-6FAFB710F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FADB728-FBC1-417F-B113-0EA5EBE2B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1C6A0A-5226-422D-8EE7-C7280E109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4998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0C070DD-DB35-4E58-80AC-E71CBC39E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DFE6B7F-F4F5-452D-B183-7BB33A4EAC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1754AAB-2994-406E-9141-302AC53285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DB6F967-6106-48A3-BB34-8A3B09B3E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4F63EAE-BD61-4D10-A9EF-3A773348F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E25503F-1245-4C4D-BFEF-4EE258B1D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8855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BD41025-36A7-44F3-88E7-D1850A284D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C61992B-0F31-40AB-A436-1F4401A4C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95DB832-BDC0-4F6A-BBED-16A4BD43E2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D1E7E67-676B-4F86-911F-9F24BA2FC1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1364D52-7C16-4CF2-8906-682CF7DF6E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9E025AB-45E9-4D0F-99E2-669C565FB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53CFE111-A5E8-4571-9216-80D236B5E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0FDB738-C6A5-4F67-842C-510DABC46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672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590B12D-9601-4B50-9378-D3CBBFB8A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732EC5D-0688-476A-AF81-47B8227AE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E2A00EC-D2C5-4389-B602-3C7C61AF7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5159296-046F-45CE-83B1-A6C548444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4505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02A3EF7-E751-40BF-919F-6A3CD02B8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9B56066-84BA-40CF-B2C2-D40E6DE17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AC64878-2754-4EA4-9140-7B6C57417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0795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816485-6991-4F10-A5CA-E113003C9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6706F0F-9209-4E48-A9EA-38ABA97544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EC1A779-7999-4236-84A1-2C77BC357E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3FF76C2-DC3F-46AE-AD3D-30B2B8B95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19B1A4F-D87F-4904-AD53-6AA7FCB46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31B8F32-E04B-4F7E-92E0-245850EFDB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7650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0028498-B6FE-48ED-AFA9-C29BF7DDA9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F785832B-07ED-4BB9-950D-AFD98920A7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490D531-EB5C-4634-97C8-752460A54F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C9D9122-D095-4A19-95A1-BB2978485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9C60999-9C16-4963-9D23-B5E545460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A05D560-B6AE-4EC6-A0C7-7EBCE773E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4041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A09F7F0-08D5-408A-91FA-F923EB85E9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0A00137-31BB-4998-A32E-F12EB4C18D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20DA6A7-D46C-4615-8E32-BBAB171724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1D8DD-A2E5-4444-95BE-96E9DB4535A3}" type="datetimeFigureOut">
              <a:rPr lang="ko-KR" altLang="en-US" smtClean="0"/>
              <a:t>2022-1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74CFDD2-E1F6-4EA2-9AF5-D26DCC9A38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026AC7-E980-48F7-A6BE-BB0D5B95C6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01F2C-1F0A-4371-9E7E-D54E0759A1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6670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56">
            <a:extLst>
              <a:ext uri="{FF2B5EF4-FFF2-40B4-BE49-F238E27FC236}">
                <a16:creationId xmlns:a16="http://schemas.microsoft.com/office/drawing/2014/main" id="{1975F6CC-9167-45E8-A982-C6454AF1333F}"/>
              </a:ext>
            </a:extLst>
          </p:cNvPr>
          <p:cNvSpPr txBox="1"/>
          <p:nvPr/>
        </p:nvSpPr>
        <p:spPr>
          <a:xfrm>
            <a:off x="219568" y="180915"/>
            <a:ext cx="34034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ko-KR" altLang="en-US" sz="2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6E3BA97-4C2B-47E5-B825-17CD0A30ADE6}"/>
              </a:ext>
            </a:extLst>
          </p:cNvPr>
          <p:cNvSpPr txBox="1"/>
          <p:nvPr/>
        </p:nvSpPr>
        <p:spPr>
          <a:xfrm>
            <a:off x="2527640" y="839746"/>
            <a:ext cx="1611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(x200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F4F23A-E84C-4871-9EE4-FA55624E3EE4}"/>
              </a:ext>
            </a:extLst>
          </p:cNvPr>
          <p:cNvSpPr txBox="1"/>
          <p:nvPr/>
        </p:nvSpPr>
        <p:spPr>
          <a:xfrm>
            <a:off x="6880358" y="839746"/>
            <a:ext cx="1611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VEGF (x200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4C8FAE-B658-48D8-BC45-1D183C6B70DE}"/>
              </a:ext>
            </a:extLst>
          </p:cNvPr>
          <p:cNvSpPr txBox="1"/>
          <p:nvPr/>
        </p:nvSpPr>
        <p:spPr>
          <a:xfrm>
            <a:off x="2304682" y="3740352"/>
            <a:ext cx="2057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Neurophilin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(x200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AB94998D-CA39-4A91-9FC4-B4655249584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6296" y="4221514"/>
            <a:ext cx="2880000" cy="2160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88EC2DE-59BA-4CFF-A29C-6B44F87B32F3}"/>
              </a:ext>
            </a:extLst>
          </p:cNvPr>
          <p:cNvSpPr txBox="1"/>
          <p:nvPr/>
        </p:nvSpPr>
        <p:spPr>
          <a:xfrm>
            <a:off x="6657400" y="3740352"/>
            <a:ext cx="2057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DGF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 (x200)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9074E5A5-87C1-42DA-B82A-F985AEA9C75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578" y="1313890"/>
            <a:ext cx="2880000" cy="21600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FFCFCA74-E990-40F4-8C0A-770C692EB31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6297" y="1313890"/>
            <a:ext cx="2879999" cy="2160000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54B60AEA-133C-4DEA-ADA5-552697F74AF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579" y="4221514"/>
            <a:ext cx="2879999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3760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56">
            <a:extLst>
              <a:ext uri="{FF2B5EF4-FFF2-40B4-BE49-F238E27FC236}">
                <a16:creationId xmlns:a16="http://schemas.microsoft.com/office/drawing/2014/main" id="{3B29AA72-849E-4115-BE4C-1C9FE969CA91}"/>
              </a:ext>
            </a:extLst>
          </p:cNvPr>
          <p:cNvSpPr txBox="1"/>
          <p:nvPr/>
        </p:nvSpPr>
        <p:spPr>
          <a:xfrm>
            <a:off x="219568" y="180915"/>
            <a:ext cx="34034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2200" b="1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ko-KR" altLang="en-US" sz="2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 descr="스크린샷이(가) 표시된 사진&#10;&#10;자동 생성된 설명">
            <a:extLst>
              <a:ext uri="{FF2B5EF4-FFF2-40B4-BE49-F238E27FC236}">
                <a16:creationId xmlns:a16="http://schemas.microsoft.com/office/drawing/2014/main" id="{A72D530C-D647-454E-8265-A33CBC2F71CD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6947" y="676268"/>
            <a:ext cx="7059410" cy="5622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7447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56">
            <a:extLst>
              <a:ext uri="{FF2B5EF4-FFF2-40B4-BE49-F238E27FC236}">
                <a16:creationId xmlns:a16="http://schemas.microsoft.com/office/drawing/2014/main" id="{1975F6CC-9167-45E8-A982-C6454AF1333F}"/>
              </a:ext>
            </a:extLst>
          </p:cNvPr>
          <p:cNvSpPr txBox="1"/>
          <p:nvPr/>
        </p:nvSpPr>
        <p:spPr>
          <a:xfrm>
            <a:off x="219568" y="180915"/>
            <a:ext cx="34034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ko-KR" altLang="en-US" sz="2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17F67683-5D4D-4194-AB47-2C2F42D50F26}"/>
              </a:ext>
            </a:extLst>
          </p:cNvPr>
          <p:cNvGrpSpPr/>
          <p:nvPr/>
        </p:nvGrpSpPr>
        <p:grpSpPr>
          <a:xfrm>
            <a:off x="6096000" y="1708184"/>
            <a:ext cx="4976327" cy="3056648"/>
            <a:chOff x="0" y="4000500"/>
            <a:chExt cx="4707467" cy="2857500"/>
          </a:xfrm>
        </p:grpSpPr>
        <p:pic>
          <p:nvPicPr>
            <p:cNvPr id="4" name="Picture 5">
              <a:extLst>
                <a:ext uri="{FF2B5EF4-FFF2-40B4-BE49-F238E27FC236}">
                  <a16:creationId xmlns:a16="http://schemas.microsoft.com/office/drawing/2014/main" id="{DA516206-939E-44B1-A613-B30AABE3ED5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4000500"/>
              <a:ext cx="3333750" cy="2857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2B09B881-6EBC-4167-AE74-045BE91D0316}"/>
                </a:ext>
              </a:extLst>
            </p:cNvPr>
            <p:cNvGrpSpPr/>
            <p:nvPr/>
          </p:nvGrpSpPr>
          <p:grpSpPr>
            <a:xfrm>
              <a:off x="1597003" y="4275462"/>
              <a:ext cx="3110464" cy="913208"/>
              <a:chOff x="2841599" y="1884844"/>
              <a:chExt cx="3110464" cy="913208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564629D-8B2B-47CE-8217-17BFF7FA92AA}"/>
                  </a:ext>
                </a:extLst>
              </p:cNvPr>
              <p:cNvSpPr txBox="1"/>
              <p:nvPr/>
            </p:nvSpPr>
            <p:spPr>
              <a:xfrm>
                <a:off x="2841599" y="1884844"/>
                <a:ext cx="31104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EJ (n=30): median 14.1 months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E8C4889-99D4-4095-9489-29BFCD0D3D92}"/>
                  </a:ext>
                </a:extLst>
              </p:cNvPr>
              <p:cNvSpPr txBox="1"/>
              <p:nvPr/>
            </p:nvSpPr>
            <p:spPr>
              <a:xfrm>
                <a:off x="2841599" y="2098835"/>
                <a:ext cx="268712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stric (n=165): median 10.8 months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직사각형 8">
                <a:extLst>
                  <a:ext uri="{FF2B5EF4-FFF2-40B4-BE49-F238E27FC236}">
                    <a16:creationId xmlns:a16="http://schemas.microsoft.com/office/drawing/2014/main" id="{E2580902-FAD1-428E-9EAF-257A24012A6B}"/>
                  </a:ext>
                </a:extLst>
              </p:cNvPr>
              <p:cNvSpPr/>
              <p:nvPr/>
            </p:nvSpPr>
            <p:spPr>
              <a:xfrm>
                <a:off x="3405886" y="2551831"/>
                <a:ext cx="57740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000" i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000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=0.16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1" name="Picture 4">
            <a:extLst>
              <a:ext uri="{FF2B5EF4-FFF2-40B4-BE49-F238E27FC236}">
                <a16:creationId xmlns:a16="http://schemas.microsoft.com/office/drawing/2014/main" id="{36BCAF0B-EB91-4518-8A76-633BD1B0AC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7719" y="1708184"/>
            <a:ext cx="3524152" cy="30566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2" name="그룹 11">
            <a:extLst>
              <a:ext uri="{FF2B5EF4-FFF2-40B4-BE49-F238E27FC236}">
                <a16:creationId xmlns:a16="http://schemas.microsoft.com/office/drawing/2014/main" id="{5FF4A500-9D9F-4E05-B681-2F89B0DF2A78}"/>
              </a:ext>
            </a:extLst>
          </p:cNvPr>
          <p:cNvGrpSpPr/>
          <p:nvPr/>
        </p:nvGrpSpPr>
        <p:grpSpPr>
          <a:xfrm>
            <a:off x="3058471" y="1992362"/>
            <a:ext cx="3028561" cy="976852"/>
            <a:chOff x="2841599" y="1884844"/>
            <a:chExt cx="2864935" cy="913208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3A9F833-8D78-4CF9-AB90-82E8E311FA86}"/>
                </a:ext>
              </a:extLst>
            </p:cNvPr>
            <p:cNvSpPr txBox="1"/>
            <p:nvPr/>
          </p:nvSpPr>
          <p:spPr>
            <a:xfrm>
              <a:off x="2841599" y="1884844"/>
              <a:ext cx="28649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GEJ (n=30): median 6.8 month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84B7C9B-8A8D-4F76-A39D-AC2E44FA10B8}"/>
                </a:ext>
              </a:extLst>
            </p:cNvPr>
            <p:cNvSpPr txBox="1"/>
            <p:nvPr/>
          </p:nvSpPr>
          <p:spPr>
            <a:xfrm>
              <a:off x="2841599" y="2098835"/>
              <a:ext cx="2600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Gastric (n=165): median 5.4 month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101FE51A-6ADC-42C6-A8A1-58E323135196}"/>
                </a:ext>
              </a:extLst>
            </p:cNvPr>
            <p:cNvSpPr/>
            <p:nvPr/>
          </p:nvSpPr>
          <p:spPr>
            <a:xfrm>
              <a:off x="3405886" y="2551831"/>
              <a:ext cx="57740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i="1" kern="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ko-KR" sz="1000" kern="0" dirty="0">
                  <a:latin typeface="Arial" panose="020B0604020202020204" pitchFamily="34" charset="0"/>
                  <a:cs typeface="Arial" panose="020B0604020202020204" pitchFamily="34" charset="0"/>
                </a:rPr>
                <a:t>=0.1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B8C13E1C-3B17-4223-B88D-73153C784E4C}"/>
              </a:ext>
            </a:extLst>
          </p:cNvPr>
          <p:cNvGrpSpPr/>
          <p:nvPr/>
        </p:nvGrpSpPr>
        <p:grpSpPr>
          <a:xfrm>
            <a:off x="7598790" y="2133999"/>
            <a:ext cx="185424" cy="228905"/>
            <a:chOff x="7977673" y="1511343"/>
            <a:chExt cx="259287" cy="228905"/>
          </a:xfrm>
        </p:grpSpPr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DDA1E9A2-52D4-41EC-9143-F2DF4A649427}"/>
                </a:ext>
              </a:extLst>
            </p:cNvPr>
            <p:cNvCxnSpPr/>
            <p:nvPr/>
          </p:nvCxnSpPr>
          <p:spPr>
            <a:xfrm>
              <a:off x="7977673" y="1511343"/>
              <a:ext cx="259287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031C772D-5BEE-4DD3-ABCC-EBE4217547D1}"/>
                </a:ext>
              </a:extLst>
            </p:cNvPr>
            <p:cNvCxnSpPr/>
            <p:nvPr/>
          </p:nvCxnSpPr>
          <p:spPr>
            <a:xfrm>
              <a:off x="7977673" y="1740248"/>
              <a:ext cx="25928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41FD038C-E86C-4B4E-A41C-C3336763815A}"/>
              </a:ext>
            </a:extLst>
          </p:cNvPr>
          <p:cNvGrpSpPr/>
          <p:nvPr/>
        </p:nvGrpSpPr>
        <p:grpSpPr>
          <a:xfrm>
            <a:off x="2864079" y="2133999"/>
            <a:ext cx="185424" cy="228905"/>
            <a:chOff x="7977673" y="1511343"/>
            <a:chExt cx="259287" cy="228905"/>
          </a:xfrm>
        </p:grpSpPr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id="{80509A35-47BE-4BEF-A021-938DC7334497}"/>
                </a:ext>
              </a:extLst>
            </p:cNvPr>
            <p:cNvCxnSpPr/>
            <p:nvPr/>
          </p:nvCxnSpPr>
          <p:spPr>
            <a:xfrm>
              <a:off x="7977673" y="1511343"/>
              <a:ext cx="259287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20A1FD29-07CB-44E1-B5CE-796AEFDD3F6B}"/>
                </a:ext>
              </a:extLst>
            </p:cNvPr>
            <p:cNvCxnSpPr/>
            <p:nvPr/>
          </p:nvCxnSpPr>
          <p:spPr>
            <a:xfrm>
              <a:off x="7977673" y="1740248"/>
              <a:ext cx="25928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427128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3150" y="4005410"/>
            <a:ext cx="3333750" cy="285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06455" y="4000500"/>
            <a:ext cx="3333750" cy="285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9234" y="954139"/>
            <a:ext cx="3333750" cy="285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5955" y="973189"/>
            <a:ext cx="3333750" cy="285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56">
            <a:extLst>
              <a:ext uri="{FF2B5EF4-FFF2-40B4-BE49-F238E27FC236}">
                <a16:creationId xmlns:a16="http://schemas.microsoft.com/office/drawing/2014/main" id="{1975F6CC-9167-45E8-A982-C6454AF1333F}"/>
              </a:ext>
            </a:extLst>
          </p:cNvPr>
          <p:cNvSpPr txBox="1"/>
          <p:nvPr/>
        </p:nvSpPr>
        <p:spPr>
          <a:xfrm>
            <a:off x="219568" y="180915"/>
            <a:ext cx="34034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ko-KR" altLang="en-US" sz="2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6">
            <a:extLst>
              <a:ext uri="{FF2B5EF4-FFF2-40B4-BE49-F238E27FC236}">
                <a16:creationId xmlns:a16="http://schemas.microsoft.com/office/drawing/2014/main" id="{6B57A702-73E6-408A-B54E-1D8F68AE51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7519" y="641907"/>
            <a:ext cx="32106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Tissue 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 H-score ≤ median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3">
            <a:extLst>
              <a:ext uri="{FF2B5EF4-FFF2-40B4-BE49-F238E27FC236}">
                <a16:creationId xmlns:a16="http://schemas.microsoft.com/office/drawing/2014/main" id="{33710BC7-5FFC-4DAD-AF26-91450D5424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0316" y="634635"/>
            <a:ext cx="321863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Tissue 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 H-score &gt; median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3A0084A3-48F1-4BD9-9C38-6ACD540CF17A}"/>
              </a:ext>
            </a:extLst>
          </p:cNvPr>
          <p:cNvGrpSpPr/>
          <p:nvPr/>
        </p:nvGrpSpPr>
        <p:grpSpPr>
          <a:xfrm>
            <a:off x="7737633" y="1033142"/>
            <a:ext cx="2826947" cy="929675"/>
            <a:chOff x="2621836" y="1899155"/>
            <a:chExt cx="2826947" cy="929675"/>
          </a:xfrm>
        </p:grpSpPr>
        <p:pic>
          <p:nvPicPr>
            <p:cNvPr id="30" name="그림 29">
              <a:extLst>
                <a:ext uri="{FF2B5EF4-FFF2-40B4-BE49-F238E27FC236}">
                  <a16:creationId xmlns:a16="http://schemas.microsoft.com/office/drawing/2014/main" id="{F05798CD-3850-4BA6-8855-9CFC34D03C7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21836" y="1932451"/>
              <a:ext cx="330694" cy="414871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1556296-3AB2-4149-80B8-926C2A90557B}"/>
                </a:ext>
              </a:extLst>
            </p:cNvPr>
            <p:cNvSpPr txBox="1"/>
            <p:nvPr/>
          </p:nvSpPr>
          <p:spPr>
            <a:xfrm>
              <a:off x="2848010" y="2105883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XP: median 5.5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E93BFB4-3CF0-40A7-84C1-116209D4DEEB}"/>
                </a:ext>
              </a:extLst>
            </p:cNvPr>
            <p:cNvSpPr txBox="1"/>
            <p:nvPr/>
          </p:nvSpPr>
          <p:spPr>
            <a:xfrm>
              <a:off x="2839840" y="1899155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+XP: median 5.6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직사각형 32">
              <a:extLst>
                <a:ext uri="{FF2B5EF4-FFF2-40B4-BE49-F238E27FC236}">
                  <a16:creationId xmlns:a16="http://schemas.microsoft.com/office/drawing/2014/main" id="{D11FA471-0EA3-4F6E-973C-CFB9C37A676D}"/>
                </a:ext>
              </a:extLst>
            </p:cNvPr>
            <p:cNvSpPr/>
            <p:nvPr/>
          </p:nvSpPr>
          <p:spPr>
            <a:xfrm>
              <a:off x="3405886" y="2551831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kern="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ko-KR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=0.272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그룹 34">
            <a:extLst>
              <a:ext uri="{FF2B5EF4-FFF2-40B4-BE49-F238E27FC236}">
                <a16:creationId xmlns:a16="http://schemas.microsoft.com/office/drawing/2014/main" id="{B92AEADF-6B97-4847-9111-8A2734D713FB}"/>
              </a:ext>
            </a:extLst>
          </p:cNvPr>
          <p:cNvGrpSpPr/>
          <p:nvPr/>
        </p:nvGrpSpPr>
        <p:grpSpPr>
          <a:xfrm>
            <a:off x="3585919" y="1018831"/>
            <a:ext cx="2820536" cy="943986"/>
            <a:chOff x="2621836" y="1884844"/>
            <a:chExt cx="2820536" cy="943986"/>
          </a:xfrm>
        </p:grpSpPr>
        <p:pic>
          <p:nvPicPr>
            <p:cNvPr id="36" name="그림 35">
              <a:extLst>
                <a:ext uri="{FF2B5EF4-FFF2-40B4-BE49-F238E27FC236}">
                  <a16:creationId xmlns:a16="http://schemas.microsoft.com/office/drawing/2014/main" id="{E3FE6632-FBDC-4656-90DE-D7CC7A71074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21836" y="1932451"/>
              <a:ext cx="330694" cy="414871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72E8B0D-19A6-4CA5-A3D6-8D9C753D742E}"/>
                </a:ext>
              </a:extLst>
            </p:cNvPr>
            <p:cNvSpPr txBox="1"/>
            <p:nvPr/>
          </p:nvSpPr>
          <p:spPr>
            <a:xfrm>
              <a:off x="2841599" y="1884844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+XP: median 6.2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5B05B2A-0824-4851-B0CA-251EAD6A1EF2}"/>
                </a:ext>
              </a:extLst>
            </p:cNvPr>
            <p:cNvSpPr txBox="1"/>
            <p:nvPr/>
          </p:nvSpPr>
          <p:spPr>
            <a:xfrm>
              <a:off x="2841599" y="2098835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XP: median 4.5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직사각형 38">
              <a:extLst>
                <a:ext uri="{FF2B5EF4-FFF2-40B4-BE49-F238E27FC236}">
                  <a16:creationId xmlns:a16="http://schemas.microsoft.com/office/drawing/2014/main" id="{BC631650-1D44-4999-A9AA-76906612B047}"/>
                </a:ext>
              </a:extLst>
            </p:cNvPr>
            <p:cNvSpPr/>
            <p:nvPr/>
          </p:nvSpPr>
          <p:spPr>
            <a:xfrm>
              <a:off x="3405886" y="2551831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kern="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ko-KR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=0.022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TextBox 6">
            <a:extLst>
              <a:ext uri="{FF2B5EF4-FFF2-40B4-BE49-F238E27FC236}">
                <a16:creationId xmlns:a16="http://schemas.microsoft.com/office/drawing/2014/main" id="{1DB30849-53EB-4CE2-AF9E-7F063218E6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61564" y="3774087"/>
            <a:ext cx="321222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9pPr>
          </a:lstStyle>
          <a:p>
            <a:pPr eaLnBrk="1" hangingPunct="1"/>
            <a:r>
              <a:rPr lang="en-GB" altLang="it-CH" sz="1600" b="1" dirty="0">
                <a:latin typeface="Arial" panose="020B0604020202020204" pitchFamily="34" charset="0"/>
                <a:cs typeface="Arial" panose="020B0604020202020204" pitchFamily="34" charset="0"/>
              </a:rPr>
              <a:t>Tissue VEGF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 H-score ≤ median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3">
            <a:extLst>
              <a:ext uri="{FF2B5EF4-FFF2-40B4-BE49-F238E27FC236}">
                <a16:creationId xmlns:a16="http://schemas.microsoft.com/office/drawing/2014/main" id="{B6BC00BF-B096-43F6-8925-BF3067C2C6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9515" y="3774087"/>
            <a:ext cx="322024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9pPr>
          </a:lstStyle>
          <a:p>
            <a:pPr eaLnBrk="1" hangingPunct="1"/>
            <a:r>
              <a:rPr lang="en-GB" altLang="it-CH" sz="1600" b="1" dirty="0">
                <a:latin typeface="Arial" panose="020B0604020202020204" pitchFamily="34" charset="0"/>
                <a:cs typeface="Arial" panose="020B0604020202020204" pitchFamily="34" charset="0"/>
              </a:rPr>
              <a:t>Tissue VEGF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 H-score &gt; median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FE6C358A-96AC-4A66-BFE5-647C2A126C98}"/>
              </a:ext>
            </a:extLst>
          </p:cNvPr>
          <p:cNvGrpSpPr/>
          <p:nvPr/>
        </p:nvGrpSpPr>
        <p:grpSpPr>
          <a:xfrm>
            <a:off x="7737633" y="4204424"/>
            <a:ext cx="2820536" cy="943986"/>
            <a:chOff x="2621836" y="1884844"/>
            <a:chExt cx="2820536" cy="943986"/>
          </a:xfrm>
        </p:grpSpPr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7D5E1F92-57A9-4868-9B62-9EE071F8AC2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21836" y="1932451"/>
              <a:ext cx="330694" cy="414871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87B3B14-67BC-41B4-98CF-411789BF68F2}"/>
                </a:ext>
              </a:extLst>
            </p:cNvPr>
            <p:cNvSpPr txBox="1"/>
            <p:nvPr/>
          </p:nvSpPr>
          <p:spPr>
            <a:xfrm>
              <a:off x="2841599" y="1884844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+XP: median 5.1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C8E8D92-8010-410D-A1C5-07E11643B60D}"/>
                </a:ext>
              </a:extLst>
            </p:cNvPr>
            <p:cNvSpPr txBox="1"/>
            <p:nvPr/>
          </p:nvSpPr>
          <p:spPr>
            <a:xfrm>
              <a:off x="2841599" y="2098835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XP: median 5.3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직사각형 46">
              <a:extLst>
                <a:ext uri="{FF2B5EF4-FFF2-40B4-BE49-F238E27FC236}">
                  <a16:creationId xmlns:a16="http://schemas.microsoft.com/office/drawing/2014/main" id="{3FCCB5BD-548A-4A00-9151-8EC742B21C49}"/>
                </a:ext>
              </a:extLst>
            </p:cNvPr>
            <p:cNvSpPr/>
            <p:nvPr/>
          </p:nvSpPr>
          <p:spPr>
            <a:xfrm>
              <a:off x="3405886" y="2551831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kern="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ko-KR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=0.186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그룹 48">
            <a:extLst>
              <a:ext uri="{FF2B5EF4-FFF2-40B4-BE49-F238E27FC236}">
                <a16:creationId xmlns:a16="http://schemas.microsoft.com/office/drawing/2014/main" id="{585972CE-C0D3-40C1-A47B-6BDB6C40803B}"/>
              </a:ext>
            </a:extLst>
          </p:cNvPr>
          <p:cNvGrpSpPr/>
          <p:nvPr/>
        </p:nvGrpSpPr>
        <p:grpSpPr>
          <a:xfrm>
            <a:off x="3598143" y="4461599"/>
            <a:ext cx="2820536" cy="943986"/>
            <a:chOff x="2621836" y="1884844"/>
            <a:chExt cx="2820536" cy="943986"/>
          </a:xfrm>
        </p:grpSpPr>
        <p:pic>
          <p:nvPicPr>
            <p:cNvPr id="50" name="그림 49">
              <a:extLst>
                <a:ext uri="{FF2B5EF4-FFF2-40B4-BE49-F238E27FC236}">
                  <a16:creationId xmlns:a16="http://schemas.microsoft.com/office/drawing/2014/main" id="{81CAB886-AAB3-45EB-AFF3-B76679CEC99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21836" y="1932451"/>
              <a:ext cx="330694" cy="414871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A17B6B6-C658-4ED1-85AD-A9897CF79BE5}"/>
                </a:ext>
              </a:extLst>
            </p:cNvPr>
            <p:cNvSpPr txBox="1"/>
            <p:nvPr/>
          </p:nvSpPr>
          <p:spPr>
            <a:xfrm>
              <a:off x="2841599" y="1884844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+XP: median 6.8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D250DB9-D976-48D4-8348-EE2EA9C842F4}"/>
                </a:ext>
              </a:extLst>
            </p:cNvPr>
            <p:cNvSpPr txBox="1"/>
            <p:nvPr/>
          </p:nvSpPr>
          <p:spPr>
            <a:xfrm>
              <a:off x="2841599" y="2098835"/>
              <a:ext cx="26007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XP: median 5.3 month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508E21D5-EC84-436B-A3BC-37543F765BB3}"/>
                </a:ext>
              </a:extLst>
            </p:cNvPr>
            <p:cNvSpPr/>
            <p:nvPr/>
          </p:nvSpPr>
          <p:spPr>
            <a:xfrm>
              <a:off x="3405886" y="2551831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kern="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ko-KR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=0.026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13764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51</Words>
  <Application>Microsoft Office PowerPoint</Application>
  <PresentationFormat>와이드스크린</PresentationFormat>
  <Paragraphs>30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Hyungdon</dc:creator>
  <cp:lastModifiedBy>Kim Hyungdon</cp:lastModifiedBy>
  <cp:revision>20</cp:revision>
  <dcterms:created xsi:type="dcterms:W3CDTF">2022-07-04T08:47:37Z</dcterms:created>
  <dcterms:modified xsi:type="dcterms:W3CDTF">2022-11-21T01:32:37Z</dcterms:modified>
</cp:coreProperties>
</file>